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wmf" ContentType="image/x-wmf"/>
  <Override PartName="/ppt/media/image4.png" ContentType="image/png"/>
  <Override PartName="/ppt/media/image5.png" ContentType="image/png"/>
  <Override PartName="/ppt/embeddings/oleObject1.bin" ContentType="application/vnd.openxmlformats-officedocument.oleObjec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62BFE3-AD53-46F2-9D6C-8D654F60D92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1BB4B9-A0BB-4A34-ACDC-758A1EADFF6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6A259F-498E-4F7A-BA64-3FC9EB051C1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1A97AB-92E6-4646-9CAD-BDB6BDE0886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816285-FA6A-4C77-8638-6BB6F4C8E37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CA2F47-4FC8-4560-B585-BE14251C83B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8EBBDE-1E8F-4B33-B631-C70CD3A6EC3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1781BF-2EF1-452A-91F2-18D53009144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FF1522-A25D-4FF1-8A83-3CF826A564C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EE3A15-3B73-40AD-8666-CBA5383A2E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B3FEA0-D7D2-4174-A0A1-5C8D2C3C05A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F8B2E7-6719-421F-9DD5-3278EEC570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EC55DA6-3A98-4D37-B95A-5636415ED737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oleObject" Target="../embeddings/oleObject1.bin"/><Relationship Id="rId4" Type="http://schemas.openxmlformats.org/officeDocument/2006/relationships/image" Target="../media/image3.wmf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Image 4" descr=""/>
          <p:cNvPicPr/>
          <p:nvPr/>
        </p:nvPicPr>
        <p:blipFill>
          <a:blip r:embed="rId1"/>
          <a:srcRect l="23317" t="11672" r="31841" b="10663"/>
          <a:stretch/>
        </p:blipFill>
        <p:spPr>
          <a:xfrm>
            <a:off x="318960" y="1001880"/>
            <a:ext cx="777960" cy="720720"/>
          </a:xfrm>
          <a:prstGeom prst="rect">
            <a:avLst/>
          </a:prstGeom>
          <a:ln w="0">
            <a:noFill/>
          </a:ln>
        </p:spPr>
      </p:pic>
      <p:sp>
        <p:nvSpPr>
          <p:cNvPr id="42" name="ZoneTexte 13"/>
          <p:cNvSpPr/>
          <p:nvPr/>
        </p:nvSpPr>
        <p:spPr>
          <a:xfrm>
            <a:off x="181080" y="884160"/>
            <a:ext cx="961920" cy="21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53.8%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ZoneTexte 14"/>
          <p:cNvSpPr/>
          <p:nvPr/>
        </p:nvSpPr>
        <p:spPr>
          <a:xfrm>
            <a:off x="826920" y="882720"/>
            <a:ext cx="852480" cy="21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28.5%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ZoneTexte 15"/>
          <p:cNvSpPr/>
          <p:nvPr/>
        </p:nvSpPr>
        <p:spPr>
          <a:xfrm>
            <a:off x="968400" y="1442880"/>
            <a:ext cx="746280" cy="21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9,9%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ZoneTexte 16"/>
          <p:cNvSpPr/>
          <p:nvPr/>
        </p:nvSpPr>
        <p:spPr>
          <a:xfrm>
            <a:off x="787320" y="1611360"/>
            <a:ext cx="681120" cy="21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7.8%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ZoneTexte 9"/>
          <p:cNvSpPr/>
          <p:nvPr/>
        </p:nvSpPr>
        <p:spPr>
          <a:xfrm>
            <a:off x="270000" y="676440"/>
            <a:ext cx="982440" cy="21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Calibri"/>
                <a:ea typeface="Arial"/>
              </a:rPr>
              <a:t>HERV-V3 chip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ZoneTexte 16"/>
          <p:cNvSpPr/>
          <p:nvPr/>
        </p:nvSpPr>
        <p:spPr>
          <a:xfrm>
            <a:off x="1352520" y="682560"/>
            <a:ext cx="893880" cy="21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Calibri"/>
                <a:ea typeface="Arial"/>
              </a:rPr>
              <a:t>Transcriptome 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ZoneTexte 8"/>
          <p:cNvSpPr/>
          <p:nvPr/>
        </p:nvSpPr>
        <p:spPr>
          <a:xfrm>
            <a:off x="177840" y="539640"/>
            <a:ext cx="65088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Rectangle 11"/>
          <p:cNvSpPr/>
          <p:nvPr/>
        </p:nvSpPr>
        <p:spPr>
          <a:xfrm>
            <a:off x="2489040" y="1073160"/>
            <a:ext cx="843120" cy="55728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ZoneTexte 3"/>
          <p:cNvSpPr/>
          <p:nvPr/>
        </p:nvSpPr>
        <p:spPr>
          <a:xfrm>
            <a:off x="2552760" y="1062000"/>
            <a:ext cx="779400" cy="21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Calibri"/>
                <a:ea typeface="Arial"/>
              </a:rPr>
              <a:t>solo LT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ZoneTexte 25"/>
          <p:cNvSpPr/>
          <p:nvPr/>
        </p:nvSpPr>
        <p:spPr>
          <a:xfrm>
            <a:off x="2567160" y="1190520"/>
            <a:ext cx="920520" cy="21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Calibri"/>
                <a:ea typeface="Arial"/>
              </a:rPr>
              <a:t>5’ LT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ZoneTexte 27"/>
          <p:cNvSpPr/>
          <p:nvPr/>
        </p:nvSpPr>
        <p:spPr>
          <a:xfrm>
            <a:off x="2558880" y="1301760"/>
            <a:ext cx="777960" cy="21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Calibri"/>
                <a:ea typeface="Arial"/>
              </a:rPr>
              <a:t>3’ LT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ZoneTexte 29"/>
          <p:cNvSpPr/>
          <p:nvPr/>
        </p:nvSpPr>
        <p:spPr>
          <a:xfrm>
            <a:off x="2557440" y="1409760"/>
            <a:ext cx="1108080" cy="21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Calibri"/>
                <a:ea typeface="Arial"/>
              </a:rPr>
              <a:t>proviral genes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Rectangle 16"/>
          <p:cNvSpPr/>
          <p:nvPr/>
        </p:nvSpPr>
        <p:spPr>
          <a:xfrm>
            <a:off x="2538360" y="1139760"/>
            <a:ext cx="65160" cy="63720"/>
          </a:xfrm>
          <a:prstGeom prst="rect">
            <a:avLst/>
          </a:prstGeom>
          <a:solidFill>
            <a:srgbClr val="ff9999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7560" rIns="97560" tIns="14760" bIns="147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Rectangle 17"/>
          <p:cNvSpPr/>
          <p:nvPr/>
        </p:nvSpPr>
        <p:spPr>
          <a:xfrm>
            <a:off x="2540160" y="1258920"/>
            <a:ext cx="64800" cy="63360"/>
          </a:xfrm>
          <a:prstGeom prst="rect">
            <a:avLst/>
          </a:prstGeom>
          <a:solidFill>
            <a:srgbClr val="92d05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7560" rIns="97560" tIns="14400" bIns="144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Rectangle 18"/>
          <p:cNvSpPr/>
          <p:nvPr/>
        </p:nvSpPr>
        <p:spPr>
          <a:xfrm>
            <a:off x="2540160" y="1380960"/>
            <a:ext cx="64800" cy="63720"/>
          </a:xfrm>
          <a:prstGeom prst="rect">
            <a:avLst/>
          </a:prstGeom>
          <a:solidFill>
            <a:srgbClr val="33cccc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7560" rIns="97560" tIns="14760" bIns="147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Rectangle 19"/>
          <p:cNvSpPr/>
          <p:nvPr/>
        </p:nvSpPr>
        <p:spPr>
          <a:xfrm>
            <a:off x="2540160" y="1501920"/>
            <a:ext cx="64800" cy="64800"/>
          </a:xfrm>
          <a:prstGeom prst="rect">
            <a:avLst/>
          </a:prstGeom>
          <a:solidFill>
            <a:srgbClr val="cc99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7560" rIns="97560" tIns="15840" bIns="1584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Rectangle 20"/>
          <p:cNvSpPr/>
          <p:nvPr/>
        </p:nvSpPr>
        <p:spPr>
          <a:xfrm>
            <a:off x="233280" y="579600"/>
            <a:ext cx="3132360" cy="12538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9" name="Picture 2" descr=""/>
          <p:cNvPicPr/>
          <p:nvPr/>
        </p:nvPicPr>
        <p:blipFill>
          <a:blip r:embed="rId2"/>
          <a:stretch/>
        </p:blipFill>
        <p:spPr>
          <a:xfrm>
            <a:off x="1411200" y="968400"/>
            <a:ext cx="776520" cy="785880"/>
          </a:xfrm>
          <a:prstGeom prst="rect">
            <a:avLst/>
          </a:prstGeom>
          <a:ln w="0">
            <a:noFill/>
          </a:ln>
        </p:spPr>
      </p:pic>
      <p:sp>
        <p:nvSpPr>
          <p:cNvPr id="60" name="ZoneTexte 14"/>
          <p:cNvSpPr/>
          <p:nvPr/>
        </p:nvSpPr>
        <p:spPr>
          <a:xfrm>
            <a:off x="1989000" y="882720"/>
            <a:ext cx="852480" cy="21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22.8%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ZoneTexte 14"/>
          <p:cNvSpPr/>
          <p:nvPr/>
        </p:nvSpPr>
        <p:spPr>
          <a:xfrm>
            <a:off x="2060640" y="1284120"/>
            <a:ext cx="852480" cy="21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11.3%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ZoneTexte 14"/>
          <p:cNvSpPr/>
          <p:nvPr/>
        </p:nvSpPr>
        <p:spPr>
          <a:xfrm>
            <a:off x="1940040" y="1565280"/>
            <a:ext cx="852480" cy="21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9.2%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ZoneTexte 14"/>
          <p:cNvSpPr/>
          <p:nvPr/>
        </p:nvSpPr>
        <p:spPr>
          <a:xfrm>
            <a:off x="1198440" y="905040"/>
            <a:ext cx="852480" cy="21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56.7%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ZoneTexte 9"/>
          <p:cNvSpPr/>
          <p:nvPr/>
        </p:nvSpPr>
        <p:spPr>
          <a:xfrm>
            <a:off x="981000" y="1838160"/>
            <a:ext cx="1546200" cy="21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Calibri"/>
                <a:ea typeface="Arial"/>
              </a:rPr>
              <a:t>LTR features  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ZoneTexte 8"/>
          <p:cNvSpPr/>
          <p:nvPr/>
        </p:nvSpPr>
        <p:spPr>
          <a:xfrm>
            <a:off x="185760" y="1797120"/>
            <a:ext cx="65088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B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Rectangle 28"/>
          <p:cNvSpPr/>
          <p:nvPr/>
        </p:nvSpPr>
        <p:spPr>
          <a:xfrm>
            <a:off x="233280" y="1833480"/>
            <a:ext cx="3132360" cy="148284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Rectangle 29"/>
          <p:cNvSpPr/>
          <p:nvPr/>
        </p:nvSpPr>
        <p:spPr>
          <a:xfrm>
            <a:off x="233280" y="3316320"/>
            <a:ext cx="3132360" cy="24559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ZoneTexte 8"/>
          <p:cNvSpPr/>
          <p:nvPr/>
        </p:nvSpPr>
        <p:spPr>
          <a:xfrm>
            <a:off x="176040" y="3289320"/>
            <a:ext cx="103032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C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69" name="Objet 5"/>
          <p:cNvGraphicFramePr/>
          <p:nvPr/>
        </p:nvGraphicFramePr>
        <p:xfrm>
          <a:off x="461880" y="2065320"/>
          <a:ext cx="2668680" cy="119556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70" name="Objet 5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461880" y="2065320"/>
                    <a:ext cx="2668680" cy="1195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pic>
        <p:nvPicPr>
          <p:cNvPr id="71" name="Picture 37" descr=""/>
          <p:cNvPicPr/>
          <p:nvPr/>
        </p:nvPicPr>
        <p:blipFill>
          <a:blip r:embed="rId5"/>
          <a:stretch/>
        </p:blipFill>
        <p:spPr>
          <a:xfrm>
            <a:off x="419040" y="3376440"/>
            <a:ext cx="2859120" cy="2352960"/>
          </a:xfrm>
          <a:prstGeom prst="rect">
            <a:avLst/>
          </a:prstGeom>
          <a:ln w="0">
            <a:noFill/>
          </a:ln>
        </p:spPr>
      </p:pic>
      <p:sp>
        <p:nvSpPr>
          <p:cNvPr id="72" name="Rectangle 33"/>
          <p:cNvSpPr/>
          <p:nvPr/>
        </p:nvSpPr>
        <p:spPr>
          <a:xfrm>
            <a:off x="3365640" y="3316320"/>
            <a:ext cx="3132000" cy="245592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3" name="Picture 19" descr=""/>
          <p:cNvPicPr/>
          <p:nvPr/>
        </p:nvPicPr>
        <p:blipFill>
          <a:blip r:embed="rId6"/>
          <a:srcRect l="0" t="0" r="14636" b="0"/>
          <a:stretch/>
        </p:blipFill>
        <p:spPr>
          <a:xfrm>
            <a:off x="3502080" y="3424320"/>
            <a:ext cx="2859120" cy="2308320"/>
          </a:xfrm>
          <a:prstGeom prst="rect">
            <a:avLst/>
          </a:prstGeom>
          <a:ln w="0">
            <a:noFill/>
          </a:ln>
        </p:spPr>
      </p:pic>
      <p:sp>
        <p:nvSpPr>
          <p:cNvPr id="74" name="ZoneTexte 8"/>
          <p:cNvSpPr/>
          <p:nvPr/>
        </p:nvSpPr>
        <p:spPr>
          <a:xfrm>
            <a:off x="3370320" y="3321000"/>
            <a:ext cx="103032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000000"/>
                </a:solidFill>
                <a:latin typeface="Calibri"/>
                <a:ea typeface="Arial"/>
              </a:rPr>
              <a:t>D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ZoneTexte 36"/>
          <p:cNvSpPr/>
          <p:nvPr/>
        </p:nvSpPr>
        <p:spPr>
          <a:xfrm>
            <a:off x="4076640" y="3340080"/>
            <a:ext cx="1916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Calibri"/>
                <a:ea typeface="Arial"/>
              </a:rPr>
              <a:t>Unique or multiple features of LT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ZoneTexte 9"/>
          <p:cNvSpPr/>
          <p:nvPr/>
        </p:nvSpPr>
        <p:spPr>
          <a:xfrm>
            <a:off x="663480" y="127080"/>
            <a:ext cx="2119320" cy="25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HERV/MaLR prototype repertoire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ZoneTexte 9"/>
          <p:cNvSpPr/>
          <p:nvPr/>
        </p:nvSpPr>
        <p:spPr>
          <a:xfrm>
            <a:off x="4118040" y="127080"/>
            <a:ext cx="2119320" cy="25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Calibri"/>
                <a:ea typeface="Arial"/>
              </a:rPr>
              <a:t>HERV/MaLR Dfam repertoire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06-17T13:20:29Z</dcterms:created>
  <dc:creator>MOMMERT Marine</dc:creator>
  <dc:description/>
  <dc:language>en-US</dc:language>
  <cp:lastModifiedBy>MOMMERT Marine</cp:lastModifiedBy>
  <dcterms:modified xsi:type="dcterms:W3CDTF">2019-10-29T14:42:46Z</dcterms:modified>
  <cp:revision>4</cp:revision>
  <dc:subject/>
  <dc:title>Présentation PowerPoint</dc:title>
</cp:coreProperties>
</file>